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ms-MY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-210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4201918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735768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433009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1752326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1488053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1382098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4233890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4149860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673927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1205660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ms-MY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ms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2839318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ms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ms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B7359-5D52-4077-B604-93E243BA0D9E}" type="datetimeFigureOut">
              <a:rPr lang="ms-MY" smtClean="0"/>
              <a:t>03/06/2020</a:t>
            </a:fld>
            <a:endParaRPr lang="ms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ms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D68EB-F6F2-4A86-89B6-95CCAC69AB47}" type="slidenum">
              <a:rPr lang="ms-MY" smtClean="0"/>
              <a:t>‹#›</a:t>
            </a:fld>
            <a:endParaRPr lang="ms-MY"/>
          </a:p>
        </p:txBody>
      </p:sp>
    </p:spTree>
    <p:extLst>
      <p:ext uri="{BB962C8B-B14F-4D97-AF65-F5344CB8AC3E}">
        <p14:creationId xmlns:p14="http://schemas.microsoft.com/office/powerpoint/2010/main" val="3652737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ms-MY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54"/>
          <p:cNvGrpSpPr/>
          <p:nvPr/>
        </p:nvGrpSpPr>
        <p:grpSpPr>
          <a:xfrm>
            <a:off x="905854" y="803305"/>
            <a:ext cx="10562602" cy="5315483"/>
            <a:chOff x="2521008" y="1196410"/>
            <a:chExt cx="7875211" cy="4549035"/>
          </a:xfrm>
        </p:grpSpPr>
        <p:sp>
          <p:nvSpPr>
            <p:cNvPr id="5" name="TextBox 4"/>
            <p:cNvSpPr txBox="1"/>
            <p:nvPr/>
          </p:nvSpPr>
          <p:spPr>
            <a:xfrm>
              <a:off x="6221339" y="1588331"/>
              <a:ext cx="2367185" cy="400110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Consented subjects </a:t>
              </a:r>
            </a:p>
            <a:p>
              <a:pPr algn="ctr"/>
              <a:r>
                <a:rPr lang="en-US" sz="1000" dirty="0" smtClean="0"/>
                <a:t>(42 GDM &amp; 38 Healthy (Control))</a:t>
              </a:r>
              <a:endParaRPr lang="ms-MY" sz="10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228457" y="2244934"/>
              <a:ext cx="2367185" cy="400110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Sample collection </a:t>
              </a:r>
              <a:r>
                <a:rPr lang="en-US" sz="1000" dirty="0" smtClean="0"/>
                <a:t>at delivery </a:t>
              </a:r>
            </a:p>
            <a:p>
              <a:pPr algn="ctr"/>
              <a:r>
                <a:rPr lang="en-US" sz="1000" dirty="0" smtClean="0"/>
                <a:t>(</a:t>
              </a:r>
              <a:r>
                <a:rPr lang="en-US" sz="1000" dirty="0" err="1" smtClean="0"/>
                <a:t>Labour</a:t>
              </a:r>
              <a:r>
                <a:rPr lang="en-US" sz="1000" dirty="0" smtClean="0"/>
                <a:t> Room)</a:t>
              </a:r>
              <a:endParaRPr lang="ms-MY" sz="10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690218" y="2878509"/>
              <a:ext cx="1531122" cy="24622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MNC Isolation</a:t>
              </a:r>
              <a:endParaRPr lang="ms-MY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639370" y="2878509"/>
              <a:ext cx="1531122" cy="553998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Maternal &amp; Perinatal data collection </a:t>
              </a:r>
              <a:r>
                <a:rPr lang="en-US" sz="1000" dirty="0" smtClean="0"/>
                <a:t>from subject’s note</a:t>
              </a:r>
              <a:endParaRPr lang="ms-MY" sz="10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588522" y="2884021"/>
              <a:ext cx="1531122" cy="400110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UCB Parameter analysis </a:t>
              </a:r>
              <a:r>
                <a:rPr lang="en-US" sz="1000" dirty="0" smtClean="0"/>
                <a:t>by Flow cytometry</a:t>
              </a:r>
              <a:endParaRPr lang="ms-MY" sz="10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690217" y="3446686"/>
              <a:ext cx="1531122" cy="400110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HSC markers expression </a:t>
              </a:r>
              <a:r>
                <a:rPr lang="en-US" sz="1000" dirty="0" smtClean="0"/>
                <a:t>by Flow cytometry</a:t>
              </a:r>
              <a:endParaRPr lang="ms-MY" sz="1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693662" y="4090998"/>
              <a:ext cx="1531122" cy="400110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CD34+ enriched cells</a:t>
              </a:r>
            </a:p>
            <a:p>
              <a:pPr algn="ctr"/>
              <a:r>
                <a:rPr lang="en-US" sz="1000" dirty="0" smtClean="0"/>
                <a:t>(post-selection)</a:t>
              </a:r>
              <a:endParaRPr lang="ms-MY" sz="10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693662" y="4754360"/>
              <a:ext cx="1531122" cy="400110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CFU assay</a:t>
              </a:r>
            </a:p>
            <a:p>
              <a:pPr algn="ctr"/>
              <a:r>
                <a:rPr lang="en-US" sz="1000" dirty="0" smtClean="0"/>
                <a:t>(HSC differentiated cells)</a:t>
              </a:r>
              <a:endParaRPr lang="ms-MY" sz="1000" dirty="0"/>
            </a:p>
          </p:txBody>
        </p:sp>
        <p:sp>
          <p:nvSpPr>
            <p:cNvPr id="14" name="Down Arrow 13"/>
            <p:cNvSpPr/>
            <p:nvPr/>
          </p:nvSpPr>
          <p:spPr>
            <a:xfrm>
              <a:off x="7313624" y="2017877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15" name="Down Arrow 14"/>
            <p:cNvSpPr/>
            <p:nvPr/>
          </p:nvSpPr>
          <p:spPr>
            <a:xfrm>
              <a:off x="7308085" y="2656789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16" name="Down Arrow 15"/>
            <p:cNvSpPr/>
            <p:nvPr/>
          </p:nvSpPr>
          <p:spPr>
            <a:xfrm>
              <a:off x="9296145" y="2658748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17" name="Down Arrow 16"/>
            <p:cNvSpPr/>
            <p:nvPr/>
          </p:nvSpPr>
          <p:spPr>
            <a:xfrm>
              <a:off x="5404958" y="2646829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cxnSp>
          <p:nvCxnSpPr>
            <p:cNvPr id="18" name="Straight Connector 17"/>
            <p:cNvCxnSpPr>
              <a:stCxn id="17" idx="0"/>
              <a:endCxn id="16" idx="0"/>
            </p:cNvCxnSpPr>
            <p:nvPr/>
          </p:nvCxnSpPr>
          <p:spPr>
            <a:xfrm>
              <a:off x="5462896" y="2646829"/>
              <a:ext cx="3891187" cy="11919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Down Arrow 18"/>
            <p:cNvSpPr/>
            <p:nvPr/>
          </p:nvSpPr>
          <p:spPr>
            <a:xfrm>
              <a:off x="5404958" y="3129217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20" name="Down Arrow 19"/>
            <p:cNvSpPr/>
            <p:nvPr/>
          </p:nvSpPr>
          <p:spPr>
            <a:xfrm>
              <a:off x="5408403" y="3860947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22" name="Down Arrow 21"/>
            <p:cNvSpPr/>
            <p:nvPr/>
          </p:nvSpPr>
          <p:spPr>
            <a:xfrm>
              <a:off x="5408403" y="4524309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196189" y="4830913"/>
              <a:ext cx="1803400" cy="24622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Statistical analysis (SPSS 17.0)</a:t>
              </a: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7575550" y="4220231"/>
              <a:ext cx="2800350" cy="146338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0350500" y="4232931"/>
              <a:ext cx="45719" cy="14617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7588250" y="5637495"/>
              <a:ext cx="2797809" cy="1079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31" name="Down Arrow 30"/>
            <p:cNvSpPr/>
            <p:nvPr/>
          </p:nvSpPr>
          <p:spPr>
            <a:xfrm>
              <a:off x="8921750" y="4232931"/>
              <a:ext cx="76200" cy="574372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33" name="Down Arrow 32"/>
            <p:cNvSpPr/>
            <p:nvPr/>
          </p:nvSpPr>
          <p:spPr>
            <a:xfrm>
              <a:off x="3608908" y="3136335"/>
              <a:ext cx="115876" cy="2032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928361" y="3453804"/>
              <a:ext cx="1531122" cy="24622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Plasma analysis</a:t>
              </a:r>
              <a:endParaRPr lang="ms-MY" sz="1000" dirty="0"/>
            </a:p>
          </p:txBody>
        </p:sp>
        <p:cxnSp>
          <p:nvCxnSpPr>
            <p:cNvPr id="35" name="Straight Connector 34"/>
            <p:cNvCxnSpPr>
              <a:stCxn id="33" idx="0"/>
            </p:cNvCxnSpPr>
            <p:nvPr/>
          </p:nvCxnSpPr>
          <p:spPr>
            <a:xfrm flipV="1">
              <a:off x="3666846" y="3134103"/>
              <a:ext cx="2539533" cy="2232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 flipH="1" flipV="1">
              <a:off x="2929556" y="3601850"/>
              <a:ext cx="2353" cy="1680108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ight Arrow 38"/>
            <p:cNvSpPr/>
            <p:nvPr/>
          </p:nvSpPr>
          <p:spPr>
            <a:xfrm>
              <a:off x="2942803" y="4826593"/>
              <a:ext cx="230621" cy="123111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188320" y="4770193"/>
              <a:ext cx="1264045" cy="24622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Insulin assay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186892" y="5144789"/>
              <a:ext cx="1264045" cy="246221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EPO assay</a:t>
              </a:r>
            </a:p>
          </p:txBody>
        </p:sp>
        <p:sp>
          <p:nvSpPr>
            <p:cNvPr id="42" name="Right Arrow 41"/>
            <p:cNvSpPr/>
            <p:nvPr/>
          </p:nvSpPr>
          <p:spPr>
            <a:xfrm>
              <a:off x="2941375" y="5201189"/>
              <a:ext cx="230621" cy="123111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ms-MY"/>
            </a:p>
          </p:txBody>
        </p:sp>
        <p:cxnSp>
          <p:nvCxnSpPr>
            <p:cNvPr id="44" name="Straight Connector 43"/>
            <p:cNvCxnSpPr/>
            <p:nvPr/>
          </p:nvCxnSpPr>
          <p:spPr>
            <a:xfrm flipV="1">
              <a:off x="2521008" y="1196411"/>
              <a:ext cx="7812162" cy="1709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10339216" y="1196410"/>
              <a:ext cx="34144" cy="302797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2521008" y="1213502"/>
              <a:ext cx="0" cy="447796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2521008" y="5694169"/>
              <a:ext cx="506724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Box 55"/>
          <p:cNvSpPr txBox="1"/>
          <p:nvPr/>
        </p:nvSpPr>
        <p:spPr>
          <a:xfrm>
            <a:off x="5761997" y="6264813"/>
            <a:ext cx="18437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DDITIONAL FILE </a:t>
            </a:r>
            <a:r>
              <a:rPr lang="en-US" sz="1600" b="1" dirty="0" smtClean="0"/>
              <a:t>1</a:t>
            </a:r>
            <a:endParaRPr lang="ms-MY" sz="1600" b="1" dirty="0"/>
          </a:p>
        </p:txBody>
      </p:sp>
    </p:spTree>
    <p:extLst>
      <p:ext uri="{BB962C8B-B14F-4D97-AF65-F5344CB8AC3E}">
        <p14:creationId xmlns:p14="http://schemas.microsoft.com/office/powerpoint/2010/main" val="220932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</TotalTime>
  <Words>70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39PF2JB</dc:creator>
  <cp:lastModifiedBy>User</cp:lastModifiedBy>
  <cp:revision>19</cp:revision>
  <dcterms:created xsi:type="dcterms:W3CDTF">2019-08-02T04:48:43Z</dcterms:created>
  <dcterms:modified xsi:type="dcterms:W3CDTF">2020-06-03T12:10:30Z</dcterms:modified>
</cp:coreProperties>
</file>